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E6BCF-AE4B-4EE2-A9C6-14F3B7502D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A2D94A-AF66-46D7-A6B3-2B68FF7ACB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28E72-D6C7-4B75-B020-19C43C9EF9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D1324-12BB-4360-B0BF-2966E28D1E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2E5B93-DFFD-4057-BD87-33AE638296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E7F6C-D259-4BB5-8EA1-3929181193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94295-E63D-4DFA-845B-68CC1A420C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C836B-B65F-4B20-B410-26C70EACDB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BC536-1589-43B0-9EE8-050ACD72C1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27CD1-75A9-4C42-B4C3-C5B4E29F42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5FDDB-F8FC-4D27-9F56-920650F85F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942D4-9597-4F18-8530-F9580EC117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9F7D7D-D5B1-4C69-9BB7-42311416B8E7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160" y="44280"/>
            <a:ext cx="2066760" cy="47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9 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8760" y="826920"/>
            <a:ext cx="6605640" cy="4079880"/>
            <a:chOff x="158760" y="826920"/>
            <a:chExt cx="6605640" cy="4079880"/>
          </a:xfrm>
        </p:grpSpPr>
        <p:sp>
          <p:nvSpPr>
            <p:cNvPr id="43" name=""/>
            <p:cNvSpPr/>
            <p:nvPr/>
          </p:nvSpPr>
          <p:spPr>
            <a:xfrm>
              <a:off x="158760" y="826920"/>
              <a:ext cx="43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"/>
            <p:cNvGrpSpPr/>
            <p:nvPr/>
          </p:nvGrpSpPr>
          <p:grpSpPr>
            <a:xfrm>
              <a:off x="177840" y="1023840"/>
              <a:ext cx="6586560" cy="3882960"/>
              <a:chOff x="177840" y="1023840"/>
              <a:chExt cx="6586560" cy="3882960"/>
            </a:xfrm>
          </p:grpSpPr>
          <p:pic>
            <p:nvPicPr>
              <p:cNvPr id="45" name="" descr=""/>
              <p:cNvPicPr/>
              <p:nvPr/>
            </p:nvPicPr>
            <p:blipFill>
              <a:blip r:embed="rId1"/>
              <a:srcRect l="7368" t="0" r="10547" b="0"/>
              <a:stretch/>
            </p:blipFill>
            <p:spPr>
              <a:xfrm>
                <a:off x="824040" y="1023840"/>
                <a:ext cx="5940360" cy="3882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"/>
              <p:cNvSpPr/>
              <p:nvPr/>
            </p:nvSpPr>
            <p:spPr>
              <a:xfrm>
                <a:off x="527040" y="2438280"/>
                <a:ext cx="183960" cy="36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" name=""/>
              <p:cNvGrpSpPr/>
              <p:nvPr/>
            </p:nvGrpSpPr>
            <p:grpSpPr>
              <a:xfrm>
                <a:off x="177840" y="3062160"/>
                <a:ext cx="759240" cy="747720"/>
                <a:chOff x="177840" y="3062160"/>
                <a:chExt cx="759240" cy="747720"/>
              </a:xfrm>
            </p:grpSpPr>
            <p:sp>
              <p:nvSpPr>
                <p:cNvPr id="48" name=""/>
                <p:cNvSpPr/>
                <p:nvPr/>
              </p:nvSpPr>
              <p:spPr>
                <a:xfrm>
                  <a:off x="178920" y="3062160"/>
                  <a:ext cx="758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THM27/MYB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178200" y="3144600"/>
                  <a:ext cx="62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4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178200" y="3240000"/>
                  <a:ext cx="662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179640" y="333504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179640" y="343656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179280" y="3531960"/>
                  <a:ext cx="517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177840" y="3627000"/>
                  <a:ext cx="686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 (</a:t>
                  </a:r>
                  <a:r>
                    <a:rPr b="1" i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y-1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)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" name=""/>
              <p:cNvGrpSpPr/>
              <p:nvPr/>
            </p:nvGrpSpPr>
            <p:grpSpPr>
              <a:xfrm>
                <a:off x="177840" y="1163520"/>
                <a:ext cx="759240" cy="747720"/>
                <a:chOff x="177840" y="1163520"/>
                <a:chExt cx="759240" cy="747720"/>
              </a:xfrm>
            </p:grpSpPr>
            <p:sp>
              <p:nvSpPr>
                <p:cNvPr id="56" name=""/>
                <p:cNvSpPr/>
                <p:nvPr/>
              </p:nvSpPr>
              <p:spPr>
                <a:xfrm>
                  <a:off x="178920" y="1163520"/>
                  <a:ext cx="758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THM27/MYB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178200" y="1245960"/>
                  <a:ext cx="62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4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178200" y="1341360"/>
                  <a:ext cx="662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179640" y="143640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179640" y="153792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179280" y="1633320"/>
                  <a:ext cx="517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77840" y="1728360"/>
                  <a:ext cx="686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 (</a:t>
                  </a:r>
                  <a:r>
                    <a:rPr b="1" i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y-1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)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" name=""/>
              <p:cNvGrpSpPr/>
              <p:nvPr/>
            </p:nvGrpSpPr>
            <p:grpSpPr>
              <a:xfrm>
                <a:off x="177840" y="2109600"/>
                <a:ext cx="759240" cy="747720"/>
                <a:chOff x="177840" y="2109600"/>
                <a:chExt cx="759240" cy="74772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178920" y="2109600"/>
                  <a:ext cx="758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THM27/MYB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178200" y="2192040"/>
                  <a:ext cx="62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4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178200" y="2287440"/>
                  <a:ext cx="662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179640" y="238248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179640" y="248400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179280" y="2579400"/>
                  <a:ext cx="517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177840" y="2674440"/>
                  <a:ext cx="686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 (</a:t>
                  </a:r>
                  <a:r>
                    <a:rPr b="1" i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y-1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)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" name=""/>
              <p:cNvGrpSpPr/>
              <p:nvPr/>
            </p:nvGrpSpPr>
            <p:grpSpPr>
              <a:xfrm>
                <a:off x="177840" y="4008240"/>
                <a:ext cx="759240" cy="747720"/>
                <a:chOff x="177840" y="4008240"/>
                <a:chExt cx="759240" cy="74772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178920" y="4008240"/>
                  <a:ext cx="758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THM27/MYB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178200" y="4090680"/>
                  <a:ext cx="62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4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178200" y="4186080"/>
                  <a:ext cx="66240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-like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179640" y="428112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179640" y="4382640"/>
                  <a:ext cx="5342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t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179280" y="4478040"/>
                  <a:ext cx="5176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177840" y="4573080"/>
                  <a:ext cx="6868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ts val="700"/>
                    </a:lnSpc>
                    <a:spcBef>
                      <a:spcPts val="700"/>
                    </a:spcBef>
                    <a:spcAft>
                      <a:spcPts val="700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Sl MYB12 (</a:t>
                  </a:r>
                  <a:r>
                    <a:rPr b="1" i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y-1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)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"/>
          <p:cNvGrpSpPr/>
          <p:nvPr/>
        </p:nvGrpSpPr>
        <p:grpSpPr>
          <a:xfrm>
            <a:off x="218160" y="419040"/>
            <a:ext cx="6334920" cy="8763120"/>
            <a:chOff x="218160" y="419040"/>
            <a:chExt cx="6334920" cy="8763120"/>
          </a:xfrm>
        </p:grpSpPr>
        <p:pic>
          <p:nvPicPr>
            <p:cNvPr id="80" name="" descr=""/>
            <p:cNvPicPr/>
            <p:nvPr/>
          </p:nvPicPr>
          <p:blipFill>
            <a:blip r:embed="rId1"/>
            <a:srcRect l="7122" t="0" r="0" b="0"/>
            <a:stretch/>
          </p:blipFill>
          <p:spPr>
            <a:xfrm>
              <a:off x="757080" y="571320"/>
              <a:ext cx="5796000" cy="8610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"/>
            <p:cNvSpPr/>
            <p:nvPr/>
          </p:nvSpPr>
          <p:spPr>
            <a:xfrm>
              <a:off x="241560" y="419040"/>
              <a:ext cx="29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048200" y="710100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189240" y="753912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743360" y="753912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100480" y="840744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006720" y="840744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863720" y="8407440"/>
              <a:ext cx="14292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"/>
            <p:cNvGrpSpPr/>
            <p:nvPr/>
          </p:nvGrpSpPr>
          <p:grpSpPr>
            <a:xfrm>
              <a:off x="218160" y="3806640"/>
              <a:ext cx="659160" cy="290880"/>
              <a:chOff x="218160" y="3806640"/>
              <a:chExt cx="659160" cy="290880"/>
            </a:xfrm>
          </p:grpSpPr>
          <p:sp>
            <p:nvSpPr>
              <p:cNvPr id="89" name=""/>
              <p:cNvSpPr/>
              <p:nvPr/>
            </p:nvSpPr>
            <p:spPr>
              <a:xfrm>
                <a:off x="219240" y="38066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18160" y="39146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"/>
            <p:cNvGrpSpPr/>
            <p:nvPr/>
          </p:nvGrpSpPr>
          <p:grpSpPr>
            <a:xfrm>
              <a:off x="218160" y="4251240"/>
              <a:ext cx="659160" cy="290880"/>
              <a:chOff x="218160" y="4251240"/>
              <a:chExt cx="659160" cy="290880"/>
            </a:xfrm>
          </p:grpSpPr>
          <p:sp>
            <p:nvSpPr>
              <p:cNvPr id="92" name=""/>
              <p:cNvSpPr/>
              <p:nvPr/>
            </p:nvSpPr>
            <p:spPr>
              <a:xfrm>
                <a:off x="219240" y="42512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18160" y="43592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"/>
            <p:cNvGrpSpPr/>
            <p:nvPr/>
          </p:nvGrpSpPr>
          <p:grpSpPr>
            <a:xfrm>
              <a:off x="218160" y="4676760"/>
              <a:ext cx="659160" cy="290520"/>
              <a:chOff x="218160" y="4676760"/>
              <a:chExt cx="659160" cy="290520"/>
            </a:xfrm>
          </p:grpSpPr>
          <p:sp>
            <p:nvSpPr>
              <p:cNvPr id="95" name=""/>
              <p:cNvSpPr/>
              <p:nvPr/>
            </p:nvSpPr>
            <p:spPr>
              <a:xfrm>
                <a:off x="219240" y="467676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18160" y="478440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218160" y="5121360"/>
              <a:ext cx="659160" cy="290520"/>
              <a:chOff x="218160" y="5121360"/>
              <a:chExt cx="659160" cy="290520"/>
            </a:xfrm>
          </p:grpSpPr>
          <p:sp>
            <p:nvSpPr>
              <p:cNvPr id="98" name=""/>
              <p:cNvSpPr/>
              <p:nvPr/>
            </p:nvSpPr>
            <p:spPr>
              <a:xfrm>
                <a:off x="219240" y="512136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18160" y="522900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"/>
            <p:cNvGrpSpPr/>
            <p:nvPr/>
          </p:nvGrpSpPr>
          <p:grpSpPr>
            <a:xfrm>
              <a:off x="218160" y="5559480"/>
              <a:ext cx="659160" cy="290520"/>
              <a:chOff x="218160" y="5559480"/>
              <a:chExt cx="659160" cy="290520"/>
            </a:xfrm>
          </p:grpSpPr>
          <p:sp>
            <p:nvSpPr>
              <p:cNvPr id="101" name=""/>
              <p:cNvSpPr/>
              <p:nvPr/>
            </p:nvSpPr>
            <p:spPr>
              <a:xfrm>
                <a:off x="219240" y="55594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18160" y="56671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"/>
            <p:cNvGrpSpPr/>
            <p:nvPr/>
          </p:nvGrpSpPr>
          <p:grpSpPr>
            <a:xfrm>
              <a:off x="218160" y="6003720"/>
              <a:ext cx="659160" cy="290880"/>
              <a:chOff x="218160" y="6003720"/>
              <a:chExt cx="659160" cy="290880"/>
            </a:xfrm>
          </p:grpSpPr>
          <p:sp>
            <p:nvSpPr>
              <p:cNvPr id="104" name=""/>
              <p:cNvSpPr/>
              <p:nvPr/>
            </p:nvSpPr>
            <p:spPr>
              <a:xfrm>
                <a:off x="219240" y="600372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18160" y="61117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"/>
            <p:cNvGrpSpPr/>
            <p:nvPr/>
          </p:nvGrpSpPr>
          <p:grpSpPr>
            <a:xfrm>
              <a:off x="218160" y="6429240"/>
              <a:ext cx="659160" cy="290880"/>
              <a:chOff x="218160" y="6429240"/>
              <a:chExt cx="659160" cy="290880"/>
            </a:xfrm>
          </p:grpSpPr>
          <p:sp>
            <p:nvSpPr>
              <p:cNvPr id="107" name=""/>
              <p:cNvSpPr/>
              <p:nvPr/>
            </p:nvSpPr>
            <p:spPr>
              <a:xfrm>
                <a:off x="219240" y="64292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18160" y="65372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9" name=""/>
            <p:cNvGrpSpPr/>
            <p:nvPr/>
          </p:nvGrpSpPr>
          <p:grpSpPr>
            <a:xfrm>
              <a:off x="218160" y="6873840"/>
              <a:ext cx="659160" cy="290880"/>
              <a:chOff x="218160" y="6873840"/>
              <a:chExt cx="659160" cy="290880"/>
            </a:xfrm>
          </p:grpSpPr>
          <p:sp>
            <p:nvSpPr>
              <p:cNvPr id="110" name=""/>
              <p:cNvSpPr/>
              <p:nvPr/>
            </p:nvSpPr>
            <p:spPr>
              <a:xfrm>
                <a:off x="219240" y="68738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18160" y="69818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2" name=""/>
            <p:cNvGrpSpPr/>
            <p:nvPr/>
          </p:nvGrpSpPr>
          <p:grpSpPr>
            <a:xfrm>
              <a:off x="218160" y="7292880"/>
              <a:ext cx="659160" cy="290880"/>
              <a:chOff x="218160" y="7292880"/>
              <a:chExt cx="659160" cy="290880"/>
            </a:xfrm>
          </p:grpSpPr>
          <p:sp>
            <p:nvSpPr>
              <p:cNvPr id="113" name=""/>
              <p:cNvSpPr/>
              <p:nvPr/>
            </p:nvSpPr>
            <p:spPr>
              <a:xfrm>
                <a:off x="219240" y="72928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18160" y="740088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"/>
            <p:cNvGrpSpPr/>
            <p:nvPr/>
          </p:nvGrpSpPr>
          <p:grpSpPr>
            <a:xfrm>
              <a:off x="218160" y="7737480"/>
              <a:ext cx="659160" cy="290520"/>
              <a:chOff x="218160" y="7737480"/>
              <a:chExt cx="659160" cy="290520"/>
            </a:xfrm>
          </p:grpSpPr>
          <p:sp>
            <p:nvSpPr>
              <p:cNvPr id="116" name=""/>
              <p:cNvSpPr/>
              <p:nvPr/>
            </p:nvSpPr>
            <p:spPr>
              <a:xfrm>
                <a:off x="219240" y="77374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18160" y="78451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"/>
            <p:cNvGrpSpPr/>
            <p:nvPr/>
          </p:nvGrpSpPr>
          <p:grpSpPr>
            <a:xfrm>
              <a:off x="218160" y="8163000"/>
              <a:ext cx="659160" cy="290520"/>
              <a:chOff x="218160" y="8163000"/>
              <a:chExt cx="659160" cy="290520"/>
            </a:xfrm>
          </p:grpSpPr>
          <p:sp>
            <p:nvSpPr>
              <p:cNvPr id="119" name=""/>
              <p:cNvSpPr/>
              <p:nvPr/>
            </p:nvSpPr>
            <p:spPr>
              <a:xfrm>
                <a:off x="219240" y="816300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18160" y="82706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"/>
            <p:cNvGrpSpPr/>
            <p:nvPr/>
          </p:nvGrpSpPr>
          <p:grpSpPr>
            <a:xfrm>
              <a:off x="218160" y="8607240"/>
              <a:ext cx="659160" cy="290880"/>
              <a:chOff x="218160" y="8607240"/>
              <a:chExt cx="659160" cy="290880"/>
            </a:xfrm>
          </p:grpSpPr>
          <p:sp>
            <p:nvSpPr>
              <p:cNvPr id="122" name=""/>
              <p:cNvSpPr/>
              <p:nvPr/>
            </p:nvSpPr>
            <p:spPr>
              <a:xfrm>
                <a:off x="219240" y="86072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18160" y="87152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"/>
            <p:cNvGrpSpPr/>
            <p:nvPr/>
          </p:nvGrpSpPr>
          <p:grpSpPr>
            <a:xfrm>
              <a:off x="218160" y="758880"/>
              <a:ext cx="659160" cy="290520"/>
              <a:chOff x="218160" y="758880"/>
              <a:chExt cx="659160" cy="290520"/>
            </a:xfrm>
          </p:grpSpPr>
          <p:sp>
            <p:nvSpPr>
              <p:cNvPr id="125" name=""/>
              <p:cNvSpPr/>
              <p:nvPr/>
            </p:nvSpPr>
            <p:spPr>
              <a:xfrm>
                <a:off x="219240" y="7588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18160" y="8665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"/>
            <p:cNvGrpSpPr/>
            <p:nvPr/>
          </p:nvGrpSpPr>
          <p:grpSpPr>
            <a:xfrm>
              <a:off x="218160" y="1184040"/>
              <a:ext cx="659160" cy="290880"/>
              <a:chOff x="218160" y="1184040"/>
              <a:chExt cx="659160" cy="290880"/>
            </a:xfrm>
          </p:grpSpPr>
          <p:sp>
            <p:nvSpPr>
              <p:cNvPr id="128" name=""/>
              <p:cNvSpPr/>
              <p:nvPr/>
            </p:nvSpPr>
            <p:spPr>
              <a:xfrm>
                <a:off x="219240" y="11840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18160" y="12920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"/>
            <p:cNvGrpSpPr/>
            <p:nvPr/>
          </p:nvGrpSpPr>
          <p:grpSpPr>
            <a:xfrm>
              <a:off x="218160" y="1628640"/>
              <a:ext cx="659160" cy="290880"/>
              <a:chOff x="218160" y="1628640"/>
              <a:chExt cx="659160" cy="290880"/>
            </a:xfrm>
          </p:grpSpPr>
          <p:sp>
            <p:nvSpPr>
              <p:cNvPr id="131" name=""/>
              <p:cNvSpPr/>
              <p:nvPr/>
            </p:nvSpPr>
            <p:spPr>
              <a:xfrm>
                <a:off x="219240" y="162864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18160" y="173664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"/>
            <p:cNvGrpSpPr/>
            <p:nvPr/>
          </p:nvGrpSpPr>
          <p:grpSpPr>
            <a:xfrm>
              <a:off x="218160" y="2066760"/>
              <a:ext cx="659160" cy="290880"/>
              <a:chOff x="218160" y="2066760"/>
              <a:chExt cx="659160" cy="290880"/>
            </a:xfrm>
          </p:grpSpPr>
          <p:sp>
            <p:nvSpPr>
              <p:cNvPr id="134" name=""/>
              <p:cNvSpPr/>
              <p:nvPr/>
            </p:nvSpPr>
            <p:spPr>
              <a:xfrm>
                <a:off x="219240" y="206676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18160" y="217476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6" name=""/>
            <p:cNvGrpSpPr/>
            <p:nvPr/>
          </p:nvGrpSpPr>
          <p:grpSpPr>
            <a:xfrm>
              <a:off x="218160" y="2511360"/>
              <a:ext cx="659160" cy="290880"/>
              <a:chOff x="218160" y="2511360"/>
              <a:chExt cx="659160" cy="290880"/>
            </a:xfrm>
          </p:grpSpPr>
          <p:sp>
            <p:nvSpPr>
              <p:cNvPr id="137" name=""/>
              <p:cNvSpPr/>
              <p:nvPr/>
            </p:nvSpPr>
            <p:spPr>
              <a:xfrm>
                <a:off x="219240" y="251136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218160" y="261936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9" name=""/>
            <p:cNvGrpSpPr/>
            <p:nvPr/>
          </p:nvGrpSpPr>
          <p:grpSpPr>
            <a:xfrm>
              <a:off x="218160" y="2936880"/>
              <a:ext cx="659160" cy="290520"/>
              <a:chOff x="218160" y="2936880"/>
              <a:chExt cx="659160" cy="290520"/>
            </a:xfrm>
          </p:grpSpPr>
          <p:sp>
            <p:nvSpPr>
              <p:cNvPr id="140" name=""/>
              <p:cNvSpPr/>
              <p:nvPr/>
            </p:nvSpPr>
            <p:spPr>
              <a:xfrm>
                <a:off x="219240" y="29368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18160" y="30445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2" name=""/>
            <p:cNvGrpSpPr/>
            <p:nvPr/>
          </p:nvGrpSpPr>
          <p:grpSpPr>
            <a:xfrm>
              <a:off x="218160" y="3381480"/>
              <a:ext cx="659160" cy="290520"/>
              <a:chOff x="218160" y="3381480"/>
              <a:chExt cx="659160" cy="290520"/>
            </a:xfrm>
          </p:grpSpPr>
          <p:sp>
            <p:nvSpPr>
              <p:cNvPr id="143" name=""/>
              <p:cNvSpPr/>
              <p:nvPr/>
            </p:nvSpPr>
            <p:spPr>
              <a:xfrm>
                <a:off x="219240" y="3381480"/>
                <a:ext cx="489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218160" y="3489120"/>
                <a:ext cx="659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ts val="700"/>
                  </a:lnSpc>
                  <a:spcBef>
                    <a:spcPts val="700"/>
                  </a:spcBef>
                  <a:spcAft>
                    <a:spcPts val="700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l MYB12 (y-1)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5" name=""/>
          <p:cNvSpPr/>
          <p:nvPr/>
        </p:nvSpPr>
        <p:spPr>
          <a:xfrm>
            <a:off x="38160" y="44280"/>
            <a:ext cx="2066760" cy="47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, Figure S9 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4:06:02Z</dcterms:modified>
  <cp:revision>12</cp:revision>
  <dc:subject/>
  <dc:title>Slide 1</dc:title>
</cp:coreProperties>
</file>